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F52DD-B450-4113-BF43-958A90B480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FD36C-A9A9-4D9C-9F20-AD4486B0BB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5EA4D-2EA3-47F2-9698-A4A3850EB2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0B7E4-01B6-48E8-9BFB-B82AB94195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037E4-FD2E-41C9-8504-2E5FB71D2E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A4586-D8E6-4108-BC2C-241A52586A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6F762-5EED-4CB9-918E-9FAC6130E0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04F51-AC25-448E-84F8-F8256CFB42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3D84C-BD0D-48D5-9984-51BC4AB59A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181D3B-2A5F-4FD8-BB80-678A3FA5B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BAB9A-6619-493F-A259-5FCD3F3F96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AFF94-8148-4C11-A34C-2C15C8F6C2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2D0559-FA15-4DA9-991D-6EA937BAB1FC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6"/>
          <p:cNvSpPr/>
          <p:nvPr/>
        </p:nvSpPr>
        <p:spPr>
          <a:xfrm>
            <a:off x="404640" y="4184640"/>
            <a:ext cx="6240600" cy="109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 LDH activity assa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DH activity of culture medium was measured using a CytoTox-ONE Homogenous Membrane Integrity Assay kit (Promega), using DMEM and cell lysates extracted with a lysis buffer containing Triton-X (0.1% v/v) as negative and positive controls, respectivel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506520" y="1187280"/>
          <a:ext cx="5940360" cy="2592720"/>
        </p:xfrm>
        <a:graphic>
          <a:graphicData uri="http://schemas.openxmlformats.org/drawingml/2006/table">
            <a:tbl>
              <a:tblPr/>
              <a:tblGrid>
                <a:gridCol w="1187280"/>
                <a:gridCol w="1189080"/>
                <a:gridCol w="1187640"/>
                <a:gridCol w="1188720"/>
                <a:gridCol w="1187640"/>
              </a:tblGrid>
              <a:tr h="432000">
                <a:tc rowSpan="2"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DH release [%]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imul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1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fepristo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00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W96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3440"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[day]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000"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1640"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rol siRN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000"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ARγ siRN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 0.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正方形/長方形 3"/>
          <p:cNvSpPr/>
          <p:nvPr/>
        </p:nvSpPr>
        <p:spPr>
          <a:xfrm>
            <a:off x="401760" y="498600"/>
            <a:ext cx="75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6T06:04:58Z</dcterms:created>
  <dc:creator>Takeshi Hashimoto</dc:creator>
  <dc:description/>
  <dc:language>en-US</dc:language>
  <cp:lastModifiedBy>Physiol2-12</cp:lastModifiedBy>
  <cp:lastPrinted>2013-02-19T23:03:05Z</cp:lastPrinted>
  <dcterms:modified xsi:type="dcterms:W3CDTF">2013-10-20T23:51:36Z</dcterms:modified>
  <cp:revision>443</cp:revision>
  <dc:subject/>
  <dc:title>スライド 1</dc:title>
</cp:coreProperties>
</file>